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7" r:id="rId2"/>
    <p:sldId id="275" r:id="rId3"/>
    <p:sldId id="276" r:id="rId4"/>
    <p:sldId id="279" r:id="rId5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70" d="100"/>
          <a:sy n="70" d="100"/>
        </p:scale>
        <p:origin x="-1498" y="1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38405" cy="384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6" tIns="46588" rIns="93176" bIns="4658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6" tIns="46588" rIns="93176" bIns="46588" rtlCol="0"/>
          <a:lstStyle>
            <a:lvl1pPr algn="r">
              <a:defRPr sz="1200"/>
            </a:lvl1pPr>
          </a:lstStyle>
          <a:p>
            <a:fld id="{8842F774-F3A4-41D3-ABBC-8BA7D43E58E0}" type="datetimeFigureOut">
              <a:rPr lang="en-US" smtClean="0"/>
              <a:t>6/23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6" tIns="46588" rIns="93176" bIns="4658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6" tIns="46588" rIns="93176" bIns="46588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6"/>
            <a:ext cx="3037840" cy="464820"/>
          </a:xfrm>
          <a:prstGeom prst="rect">
            <a:avLst/>
          </a:prstGeom>
        </p:spPr>
        <p:txBody>
          <a:bodyPr vert="horz" lIns="93176" tIns="46588" rIns="93176" bIns="4658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6"/>
            <a:ext cx="3037840" cy="464820"/>
          </a:xfrm>
          <a:prstGeom prst="rect">
            <a:avLst/>
          </a:prstGeom>
        </p:spPr>
        <p:txBody>
          <a:bodyPr vert="horz" lIns="93176" tIns="46588" rIns="93176" bIns="46588" rtlCol="0" anchor="b"/>
          <a:lstStyle>
            <a:lvl1pPr algn="r">
              <a:defRPr sz="1200"/>
            </a:lvl1pPr>
          </a:lstStyle>
          <a:p>
            <a:fld id="{08F6E7DD-BFA9-4B41-A476-D9F8D53C4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9332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7C357-3239-4D96-9EDA-9E048475469B}" type="datetime1">
              <a:rPr lang="en-US" smtClean="0"/>
              <a:t>6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644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35831-0603-44CA-940F-71B9F8A3E2F3}" type="datetime1">
              <a:rPr lang="en-US" smtClean="0"/>
              <a:t>6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566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82DEC-07A3-44F0-B60E-1594E025701F}" type="datetime1">
              <a:rPr lang="en-US" smtClean="0"/>
              <a:t>6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560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C792C-46DF-4614-8A53-AB1182F639B7}" type="datetime1">
              <a:rPr lang="en-US" smtClean="0"/>
              <a:t>6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128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8F63-6716-4527-950C-B0E263956400}" type="datetime1">
              <a:rPr lang="en-US" smtClean="0"/>
              <a:t>6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54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3D5B1-F10F-428E-836B-1D58537CA387}" type="datetime1">
              <a:rPr lang="en-US" smtClean="0"/>
              <a:t>6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170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4907-DCF8-4986-B348-3DC43465467E}" type="datetime1">
              <a:rPr lang="en-US" smtClean="0"/>
              <a:t>6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054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5BF-8EFF-4535-BE03-2F484C2BC335}" type="datetime1">
              <a:rPr lang="en-US" smtClean="0"/>
              <a:t>6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714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C7F5C-97A4-4184-8745-BD96C0F79490}" type="datetime1">
              <a:rPr lang="en-US" smtClean="0"/>
              <a:t>6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022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1A73E-EB10-4DC7-AD3F-ED918D3FB91B}" type="datetime1">
              <a:rPr lang="en-US" smtClean="0"/>
              <a:t>6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333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2887B-A6FB-4DFF-8D4B-51126DCC400A}" type="datetime1">
              <a:rPr lang="en-US" smtClean="0"/>
              <a:t>6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636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9EC92-0F8B-4EC1-929B-0D397E6059C6}" type="datetime1">
              <a:rPr lang="en-US" smtClean="0"/>
              <a:t>6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smtClean="0"/>
              <a:t>Quest Diagnostics (Birse), NLST-ACRIN Application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635F86-7BD1-4222-9F1D-BC1983B6E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075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02245" y="5692299"/>
            <a:ext cx="545351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Additional file 2: Figure S1. </a:t>
            </a:r>
            <a:r>
              <a:rPr lang="en-US" sz="1200" dirty="0"/>
              <a:t>ROC curve showing diagnostic accuracy of Pulmonary Nodule Classifier (PNC) evaluated in </a:t>
            </a:r>
            <a:r>
              <a:rPr lang="en-US" sz="1200" dirty="0" smtClean="0"/>
              <a:t>the training </a:t>
            </a:r>
            <a:r>
              <a:rPr lang="en-US" sz="1200" dirty="0"/>
              <a:t>study (lung </a:t>
            </a:r>
            <a:r>
              <a:rPr lang="en-US" sz="1200" dirty="0" smtClean="0"/>
              <a:t>cancer </a:t>
            </a:r>
            <a:r>
              <a:rPr lang="en-US" sz="1200" dirty="0"/>
              <a:t>n = </a:t>
            </a:r>
            <a:r>
              <a:rPr lang="en-US" sz="1200" dirty="0" smtClean="0"/>
              <a:t>95; healthy smoker control </a:t>
            </a:r>
            <a:r>
              <a:rPr lang="en-US" sz="1200" dirty="0"/>
              <a:t>n = </a:t>
            </a:r>
            <a:r>
              <a:rPr lang="en-US" sz="1200" dirty="0" smtClean="0"/>
              <a:t>186). Area </a:t>
            </a:r>
            <a:r>
              <a:rPr lang="en-US" sz="1200" dirty="0"/>
              <a:t>under the curve (AUC) and 95% confidence intervals are shown.</a:t>
            </a:r>
          </a:p>
          <a:p>
            <a:endParaRPr lang="en-US" sz="1200" dirty="0"/>
          </a:p>
        </p:txBody>
      </p:sp>
      <p:grpSp>
        <p:nvGrpSpPr>
          <p:cNvPr id="13" name="Group 12"/>
          <p:cNvGrpSpPr/>
          <p:nvPr/>
        </p:nvGrpSpPr>
        <p:grpSpPr>
          <a:xfrm>
            <a:off x="878457" y="786538"/>
            <a:ext cx="4739628" cy="4642304"/>
            <a:chOff x="878457" y="786538"/>
            <a:chExt cx="4739628" cy="4642304"/>
          </a:xfrm>
        </p:grpSpPr>
        <p:pic>
          <p:nvPicPr>
            <p:cNvPr id="7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8457" y="786538"/>
              <a:ext cx="4739628" cy="46423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Rectangle 4"/>
            <p:cNvSpPr/>
            <p:nvPr/>
          </p:nvSpPr>
          <p:spPr>
            <a:xfrm>
              <a:off x="1959429" y="4586045"/>
              <a:ext cx="1783603" cy="2363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3372941" y="4725987"/>
              <a:ext cx="28465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242645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9820" y="5684940"/>
            <a:ext cx="56183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</a:t>
            </a:r>
            <a:r>
              <a:rPr lang="en-US" sz="1200" b="1" dirty="0" smtClean="0"/>
              <a:t>file </a:t>
            </a:r>
            <a:r>
              <a:rPr lang="en-US" sz="1200" b="1" dirty="0"/>
              <a:t>2: </a:t>
            </a:r>
            <a:r>
              <a:rPr lang="en-US" sz="1200" b="1" dirty="0" smtClean="0"/>
              <a:t>Figure S2.  </a:t>
            </a:r>
            <a:r>
              <a:rPr lang="en-US" sz="1200" dirty="0" smtClean="0"/>
              <a:t>ROC curve showing diagnostic accuracy of Pulmonary Nodule Classifier (PNC) evaluated in the nodule population of the PLCO validation </a:t>
            </a:r>
            <a:r>
              <a:rPr lang="en-US" sz="1200" dirty="0"/>
              <a:t>study (lung cancer </a:t>
            </a:r>
            <a:r>
              <a:rPr lang="en-US" sz="1200" dirty="0" smtClean="0"/>
              <a:t>n = 119</a:t>
            </a:r>
            <a:r>
              <a:rPr lang="en-US" sz="1200" dirty="0"/>
              <a:t>; benign nodule </a:t>
            </a:r>
            <a:r>
              <a:rPr lang="en-US" sz="1200" dirty="0" smtClean="0"/>
              <a:t>n = 119). Area under the curve (AUC) and 95% confidence intervals are shown.</a:t>
            </a:r>
            <a:endParaRPr lang="en-US" sz="1200" dirty="0"/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630" y="846715"/>
            <a:ext cx="4646381" cy="4587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5466864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96498" y="5692299"/>
            <a:ext cx="55303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</a:t>
            </a:r>
            <a:r>
              <a:rPr lang="en-US" sz="1200" b="1" dirty="0" smtClean="0"/>
              <a:t>file </a:t>
            </a:r>
            <a:r>
              <a:rPr lang="en-US" sz="1200" b="1" dirty="0"/>
              <a:t>2: </a:t>
            </a:r>
            <a:r>
              <a:rPr lang="en-US" sz="1200" b="1" dirty="0" smtClean="0"/>
              <a:t>Figure S3.  </a:t>
            </a:r>
            <a:r>
              <a:rPr lang="en-US" sz="1200" dirty="0" smtClean="0"/>
              <a:t>ROC curves showing diagnostic accuracy of Pulmonary Nodule Classifier (PNC) evaluated in PLCO validation study populations: nodules (n = 238; black), masses (n = 100; blue), other findings (n = 56; red</a:t>
            </a:r>
            <a:r>
              <a:rPr lang="en-US" sz="1200" dirty="0"/>
              <a:t>). </a:t>
            </a:r>
            <a:r>
              <a:rPr lang="en-US" sz="1200" dirty="0" smtClean="0"/>
              <a:t>Area </a:t>
            </a:r>
            <a:r>
              <a:rPr lang="en-US" sz="1200" dirty="0"/>
              <a:t>under the curve (AUC) and 95% confidence intervals are shown.</a:t>
            </a:r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4270" y="731500"/>
            <a:ext cx="4608600" cy="46620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001527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31182" y="5082683"/>
            <a:ext cx="57478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</a:t>
            </a:r>
            <a:r>
              <a:rPr lang="en-US" sz="1200" b="1" dirty="0" smtClean="0"/>
              <a:t>file </a:t>
            </a:r>
            <a:r>
              <a:rPr lang="en-US" sz="1200" b="1" dirty="0"/>
              <a:t>2: </a:t>
            </a:r>
            <a:r>
              <a:rPr lang="en-US" sz="1200" b="1" dirty="0" smtClean="0"/>
              <a:t>Figure S4.  </a:t>
            </a:r>
            <a:r>
              <a:rPr lang="en-US" sz="1200" dirty="0" smtClean="0"/>
              <a:t>Distribution of PNC signal </a:t>
            </a:r>
            <a:r>
              <a:rPr lang="en-US" sz="1200" dirty="0"/>
              <a:t>in controls (</a:t>
            </a:r>
            <a:r>
              <a:rPr lang="en-US" sz="1200" dirty="0" smtClean="0"/>
              <a:t>blue) and cases </a:t>
            </a:r>
            <a:r>
              <a:rPr lang="en-US" sz="1200" dirty="0"/>
              <a:t>(red</a:t>
            </a:r>
            <a:r>
              <a:rPr lang="en-US" sz="1200" dirty="0" smtClean="0"/>
              <a:t>) in  the  </a:t>
            </a:r>
            <a:r>
              <a:rPr lang="en-US" sz="1200" dirty="0"/>
              <a:t>training </a:t>
            </a:r>
            <a:r>
              <a:rPr lang="en-US" sz="1200" dirty="0" smtClean="0"/>
              <a:t>and validation studies. </a:t>
            </a:r>
          </a:p>
          <a:p>
            <a:endParaRPr lang="en-US" sz="1200" dirty="0"/>
          </a:p>
          <a:p>
            <a:endParaRPr lang="en-US" sz="1200" dirty="0" smtClean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777" y="927061"/>
            <a:ext cx="5791200" cy="382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48954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16</TotalTime>
  <Words>204</Words>
  <Application>Microsoft Office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Quest Diagnostic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rsece</dc:creator>
  <cp:lastModifiedBy>Birse, Charles E</cp:lastModifiedBy>
  <cp:revision>148</cp:revision>
  <cp:lastPrinted>2016-07-02T00:30:27Z</cp:lastPrinted>
  <dcterms:created xsi:type="dcterms:W3CDTF">2014-07-11T17:15:24Z</dcterms:created>
  <dcterms:modified xsi:type="dcterms:W3CDTF">2017-06-26T17:48:41Z</dcterms:modified>
</cp:coreProperties>
</file>